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ED669-C10E-4127-A9AC-34CBC1A929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46BC9-FBC6-4325-9411-B1DE9E8BE4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AF23D-6A8D-45A4-9EDD-CBBD6711C8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B9D10E-E824-46A1-BDA8-D2BBB28A62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2189A-6668-4AFC-B357-6A1C66E5A8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1DFFC-F7E5-4028-B753-561788E734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DD734-46CB-41B4-BE12-F020F92231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94FE30-7F46-4CE6-952F-36D3634E49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29683-B8A9-4639-84F3-96A0934945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7B96E-D4F4-4598-A70F-5256A9442C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6D37E-BA01-4120-B4FB-CD3B62A393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948C1-15D6-41C2-B06B-42F0E0543B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F0924E-C189-464F-8A4C-A377EA16AE0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32400" y="649440"/>
            <a:ext cx="624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i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R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62880" y="649440"/>
            <a:ext cx="426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608840" y="1004760"/>
            <a:ext cx="74844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E-cadher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608840" y="2243160"/>
            <a:ext cx="74844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P-cadher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609920" y="2784600"/>
            <a:ext cx="536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609920" y="1620720"/>
            <a:ext cx="536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270000" y="946080"/>
            <a:ext cx="1376280" cy="219384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464760" y="131292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046160" y="132228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9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66200" y="194472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047600" y="195264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9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72680" y="256860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054080" y="257652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72680" y="310356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054080" y="311148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.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202200" y="635040"/>
            <a:ext cx="624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i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R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633040" y="635040"/>
            <a:ext cx="426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867480" y="857160"/>
            <a:ext cx="75024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Integrin-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868920" y="1308240"/>
            <a:ext cx="536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867480" y="1841400"/>
            <a:ext cx="74412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Integrin-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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868920" y="2379600"/>
            <a:ext cx="536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868200" y="3067200"/>
            <a:ext cx="734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Integrin-</a:t>
            </a: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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868920" y="3790800"/>
            <a:ext cx="536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163200" y="961920"/>
            <a:ext cx="67392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caten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164280" y="2684520"/>
            <a:ext cx="536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164280" y="1479600"/>
            <a:ext cx="536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163560" y="2070000"/>
            <a:ext cx="66492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caten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164280" y="3722760"/>
            <a:ext cx="536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6164280" y="3246480"/>
            <a:ext cx="49860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P-1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455080" y="593640"/>
            <a:ext cx="624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i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R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885560" y="593640"/>
            <a:ext cx="426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2"/>
          <a:stretch/>
        </p:blipFill>
        <p:spPr>
          <a:xfrm>
            <a:off x="2522520" y="811080"/>
            <a:ext cx="1371600" cy="3308400"/>
          </a:xfrm>
          <a:prstGeom prst="rect">
            <a:avLst/>
          </a:prstGeom>
          <a:ln w="0">
            <a:noFill/>
          </a:ln>
        </p:spPr>
      </p:pic>
      <p:sp>
        <p:nvSpPr>
          <p:cNvPr id="73" name=""/>
          <p:cNvSpPr/>
          <p:nvPr/>
        </p:nvSpPr>
        <p:spPr>
          <a:xfrm>
            <a:off x="2746080" y="110340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327480" y="111132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.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742840" y="152388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323880" y="1533600"/>
            <a:ext cx="33408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763360" y="210492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303720" y="211140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763360" y="267336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303720" y="268128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763360" y="343692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303720" y="344340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9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763360" y="406080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281400" y="406728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7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" descr=""/>
          <p:cNvPicPr/>
          <p:nvPr/>
        </p:nvPicPr>
        <p:blipFill>
          <a:blip r:embed="rId3"/>
          <a:stretch/>
        </p:blipFill>
        <p:spPr>
          <a:xfrm>
            <a:off x="4794120" y="804960"/>
            <a:ext cx="1386000" cy="3332160"/>
          </a:xfrm>
          <a:prstGeom prst="rect">
            <a:avLst/>
          </a:prstGeom>
          <a:ln w="0">
            <a:noFill/>
          </a:ln>
        </p:spPr>
      </p:pic>
      <p:sp>
        <p:nvSpPr>
          <p:cNvPr id="86" name=""/>
          <p:cNvSpPr/>
          <p:nvPr/>
        </p:nvSpPr>
        <p:spPr>
          <a:xfrm>
            <a:off x="5011200" y="124128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592600" y="124776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7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008320" y="180036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589720" y="180972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5028840" y="242244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5567040" y="2432160"/>
            <a:ext cx="33408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5028840" y="297648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5567400" y="2984400"/>
            <a:ext cx="39024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0.9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028840" y="349884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567040" y="3508200"/>
            <a:ext cx="33408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028840" y="4108320"/>
            <a:ext cx="24876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5557320" y="4092480"/>
            <a:ext cx="334080" cy="21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1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8" name="" descr=""/>
          <p:cNvPicPr/>
          <p:nvPr/>
        </p:nvPicPr>
        <p:blipFill>
          <a:blip r:embed="rId4"/>
          <a:stretch/>
        </p:blipFill>
        <p:spPr>
          <a:xfrm>
            <a:off x="487440" y="5103720"/>
            <a:ext cx="2090520" cy="126864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5"/>
          <a:stretch/>
        </p:blipFill>
        <p:spPr>
          <a:xfrm>
            <a:off x="3951360" y="5351400"/>
            <a:ext cx="1731960" cy="920880"/>
          </a:xfrm>
          <a:prstGeom prst="rect">
            <a:avLst/>
          </a:prstGeom>
          <a:ln w="0">
            <a:noFill/>
          </a:ln>
        </p:spPr>
      </p:pic>
      <p:sp>
        <p:nvSpPr>
          <p:cNvPr id="100" name=""/>
          <p:cNvSpPr/>
          <p:nvPr/>
        </p:nvSpPr>
        <p:spPr>
          <a:xfrm rot="19660800">
            <a:off x="1348200" y="4801680"/>
            <a:ext cx="624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i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R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rot="19671600">
            <a:off x="836280" y="4817880"/>
            <a:ext cx="426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rot="19660800">
            <a:off x="1932480" y="4677840"/>
            <a:ext cx="624960" cy="37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anti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iR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rot="19660800">
            <a:off x="4672440" y="5067000"/>
            <a:ext cx="624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i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R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rot="19671600">
            <a:off x="4144320" y="5084280"/>
            <a:ext cx="426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GF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rot="19660800">
            <a:off x="5245920" y="4912920"/>
            <a:ext cx="624960" cy="37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anti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iR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667120" y="5446800"/>
            <a:ext cx="84168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Pre-mi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R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502360" y="5459400"/>
            <a:ext cx="48492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CD4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5638320" y="5940360"/>
            <a:ext cx="10137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Mature mi</a:t>
            </a:r>
            <a:r>
              <a:rPr b="0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R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-3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496600" y="5952960"/>
            <a:ext cx="4359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5760" rIns="95760" tIns="47880" bIns="47880" anchor="t">
            <a:spAutoFit/>
          </a:bodyPr>
          <a:p>
            <a:pPr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acti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15920" y="46800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689280" y="48229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-25560" y="4636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8T15:44:45Z</dcterms:created>
  <dc:creator>B. Yang</dc:creator>
  <dc:description/>
  <dc:language>en-US</dc:language>
  <cp:lastModifiedBy>B. Yang</cp:lastModifiedBy>
  <dcterms:modified xsi:type="dcterms:W3CDTF">2008-05-08T15:48:11Z</dcterms:modified>
  <cp:revision>1</cp:revision>
  <dc:subject/>
  <dc:title>Slide 1</dc:title>
</cp:coreProperties>
</file>